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92" r:id="rId5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CC6BE3C-6811-3921-9B8B-16B182B419A5}" name="kose yujiro" initials="ky" userId="6f5591f4893ee1ef" providerId="Windows Live"/>
  <p188:author id="{1F35518A-3B4C-9518-75C6-DD6220FDD741}" name="Melissa Leffler" initials="ML" userId="417716030a4135da" providerId="Windows Live"/>
  <p188:author id="{8A9BE3C6-2BD8-18E4-2BA0-FB25BEC19AF5}" name="Ben Knight" initials="BK" userId="e3b0decf033e1e5e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Benjamin Knight" initials="BK" lastIdx="3" clrIdx="0"/>
  <p:cmAuthor id="2" name="Liz Charpleix" initials="LC" lastIdx="4" clrIdx="1">
    <p:extLst>
      <p:ext uri="{19B8F6BF-5375-455C-9EA6-DF929625EA0E}">
        <p15:presenceInfo xmlns:p15="http://schemas.microsoft.com/office/powerpoint/2012/main" userId="Liz Charpleix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43" autoAdjust="0"/>
    <p:restoredTop sz="95673"/>
  </p:normalViewPr>
  <p:slideViewPr>
    <p:cSldViewPr snapToGrid="0" showGuides="1">
      <p:cViewPr varScale="1">
        <p:scale>
          <a:sx n="79" d="100"/>
          <a:sy n="79" d="100"/>
        </p:scale>
        <p:origin x="120" y="17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commentAuthors" Target="commentAuthors.xml"/><Relationship Id="rId11" Type="http://schemas.microsoft.com/office/2018/10/relationships/authors" Target="authors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90D2475-FA54-48D6-9152-0FB717439CB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F800CEF3-C180-47E1-AECF-5B6B8472ACD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B288868-CA01-4884-BF55-BB5FFE4892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3DDAD-8809-49B4-AE30-5BD136CC2901}" type="datetimeFigureOut">
              <a:rPr kumimoji="1" lang="ja-JP" altLang="en-US" smtClean="0"/>
              <a:t>2025/7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B9BB2A2-4A72-4B4A-A49C-1A46B31D4B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850F460-7EE5-448E-93D5-CE97CFA6D9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A4DE35-68AC-4C25-BA39-2486525410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93088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FA5C7AF-A5B9-4B4E-A499-8D60FAEE3C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EC457AF-708C-4BC8-97FE-BE2634E916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EDB282E-0943-4F51-80A6-5346FA65E8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3DDAD-8809-49B4-AE30-5BD136CC2901}" type="datetimeFigureOut">
              <a:rPr kumimoji="1" lang="ja-JP" altLang="en-US" smtClean="0"/>
              <a:t>2025/7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E41B561-A144-43AB-B296-8F993B18C9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EDE375A-E265-4F78-A52A-75AF861C30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A4DE35-68AC-4C25-BA39-2486525410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41106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27C8A8DF-F7CC-499A-AC87-96B809F7C24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F09F066-860E-4FDF-A760-21A0F9355D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E33C2AD-7C73-4C19-8E2C-6D3BAE6251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3DDAD-8809-49B4-AE30-5BD136CC2901}" type="datetimeFigureOut">
              <a:rPr kumimoji="1" lang="ja-JP" altLang="en-US" smtClean="0"/>
              <a:t>2025/7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DC38322-E9F2-47DC-AE6F-4FEAA4118C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13A0D0C-F425-49C3-A278-C61F0E2315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A4DE35-68AC-4C25-BA39-2486525410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60173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D523323-4C7E-42B0-A845-0FC2C0B8DD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BAED4D4-00DD-4369-A122-6A91A6AE75A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F4C56A4-398E-4D36-B6F2-A9A8B6FF0A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3DDAD-8809-49B4-AE30-5BD136CC2901}" type="datetimeFigureOut">
              <a:rPr kumimoji="1" lang="ja-JP" altLang="en-US" smtClean="0"/>
              <a:t>2025/7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B13EC76-2737-4F7A-9276-D6DB487580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701F573-674F-48C2-A401-95127B22CE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A4DE35-68AC-4C25-BA39-2486525410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4016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71E2A45-CDA0-412D-8451-C1F9B08203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E22250D-BDB7-4788-BA9E-24CCA1630B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7B3B9F4-CB39-4115-9F96-5C98C42B05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3DDAD-8809-49B4-AE30-5BD136CC2901}" type="datetimeFigureOut">
              <a:rPr kumimoji="1" lang="ja-JP" altLang="en-US" smtClean="0"/>
              <a:t>2025/7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E1D2466-CCC7-4412-B38F-900D6CE24D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AEAE3FD-08B7-486A-AF0A-AEB67C3997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A4DE35-68AC-4C25-BA39-2486525410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88567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420AE59-FBC3-4768-B6DE-1A25171C7E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4BFAFF7-FD79-4EFB-8ACC-2D9BA6EE37D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78589B8-E407-44E6-94D5-323CB2460FB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603F03E-1704-43D5-8F5A-243005CD62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3DDAD-8809-49B4-AE30-5BD136CC2901}" type="datetimeFigureOut">
              <a:rPr kumimoji="1" lang="ja-JP" altLang="en-US" smtClean="0"/>
              <a:t>2025/7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309B087-F348-48CF-8072-F156754B07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DE19B9B-9651-46FC-B180-180607FD0B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A4DE35-68AC-4C25-BA39-2486525410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07032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1F1C877-0E31-4B9A-8732-D2C89789DB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C156745-AF6A-4BD2-B713-916D8C1A87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DE6DA58-D4C6-42F3-A832-1EDAC09FC0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D43CE625-37E6-4A9E-A7FB-2E163EAA389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2A2D7406-5A5B-4321-B13C-C132B9453F9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24F0A915-F4AE-487D-9655-EADA222402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3DDAD-8809-49B4-AE30-5BD136CC2901}" type="datetimeFigureOut">
              <a:rPr kumimoji="1" lang="ja-JP" altLang="en-US" smtClean="0"/>
              <a:t>2025/7/3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385A159B-BEBB-4E18-827B-CB05E61AFB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5F1B8D2F-5846-421D-89BE-07015DCF8D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A4DE35-68AC-4C25-BA39-2486525410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44937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C4089FE-C7D6-409A-9F00-0AF5CA98C4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0A7606C4-625C-4A0B-BA78-CAF0D3B114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3DDAD-8809-49B4-AE30-5BD136CC2901}" type="datetimeFigureOut">
              <a:rPr kumimoji="1" lang="ja-JP" altLang="en-US" smtClean="0"/>
              <a:t>2025/7/3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B3960148-C484-4DB8-A9B0-2BE2E258E0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999BD209-02D5-48DC-92EE-4C15B03C6B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A4DE35-68AC-4C25-BA39-2486525410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11473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0EC66B77-C7D7-4263-ACED-8FF5D0756C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3DDAD-8809-49B4-AE30-5BD136CC2901}" type="datetimeFigureOut">
              <a:rPr kumimoji="1" lang="ja-JP" altLang="en-US" smtClean="0"/>
              <a:t>2025/7/3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ED43F204-59A6-45DD-8895-8FAB792C84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2331E97-85BE-4A93-9164-38221F818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A4DE35-68AC-4C25-BA39-2486525410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47448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08CCB53-25C7-4B87-99A5-48F084A71C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AAA5426-A366-4E77-823D-9FF3681EEC9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801866E-09F2-458A-B713-5E4A8C5DF1E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9E73993-7C7A-4DE1-9E7A-B31CD685CD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3DDAD-8809-49B4-AE30-5BD136CC2901}" type="datetimeFigureOut">
              <a:rPr kumimoji="1" lang="ja-JP" altLang="en-US" smtClean="0"/>
              <a:t>2025/7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33440BE-9C92-4DCD-B3B7-1972CEC52B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5074C76-3599-48FB-91D9-0D41B645EC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A4DE35-68AC-4C25-BA39-2486525410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02969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8C7EAC4-8463-4AFA-8E55-C3D198BCE6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BDE3C7AD-3F44-4F60-80F3-B6BFDEACCFB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5F64D30-6577-44E3-82BE-0C3C2BACD3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5EB462E-81B8-4C4A-954D-6E1A5F4E0E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3DDAD-8809-49B4-AE30-5BD136CC2901}" type="datetimeFigureOut">
              <a:rPr kumimoji="1" lang="ja-JP" altLang="en-US" smtClean="0"/>
              <a:t>2025/7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362521A-0D39-4F54-8E6F-7B27B2E606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7B2C00D-141D-4E9F-A05F-439C6F582B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A4DE35-68AC-4C25-BA39-2486525410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99529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AA8DECF5-07DB-4E0F-8FFA-602B07D403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3807397-F60B-4B16-A81C-06A4CD007E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77A8B1B-C920-480A-BD2A-7CC174EFDF4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B3DDAD-8809-49B4-AE30-5BD136CC2901}" type="datetimeFigureOut">
              <a:rPr kumimoji="1" lang="ja-JP" altLang="en-US" smtClean="0"/>
              <a:t>2025/7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60B160E-5B34-478E-A93B-3668B0C806E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5E9EB2F-CD5D-4413-BD90-826BACF5C25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A4DE35-68AC-4C25-BA39-2486525410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69175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468D749A-4942-C5DD-368B-ED00E2E8573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03419734"/>
              </p:ext>
            </p:extLst>
          </p:nvPr>
        </p:nvGraphicFramePr>
        <p:xfrm>
          <a:off x="3173503" y="1343196"/>
          <a:ext cx="5430466" cy="3675798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90521">
                  <a:extLst>
                    <a:ext uri="{9D8B030D-6E8A-4147-A177-3AD203B41FA5}">
                      <a16:colId xmlns:a16="http://schemas.microsoft.com/office/drawing/2014/main" val="1401792900"/>
                    </a:ext>
                  </a:extLst>
                </a:gridCol>
                <a:gridCol w="2035992">
                  <a:extLst>
                    <a:ext uri="{9D8B030D-6E8A-4147-A177-3AD203B41FA5}">
                      <a16:colId xmlns:a16="http://schemas.microsoft.com/office/drawing/2014/main" val="2823234473"/>
                    </a:ext>
                  </a:extLst>
                </a:gridCol>
                <a:gridCol w="235270">
                  <a:extLst>
                    <a:ext uri="{9D8B030D-6E8A-4147-A177-3AD203B41FA5}">
                      <a16:colId xmlns:a16="http://schemas.microsoft.com/office/drawing/2014/main" val="157089638"/>
                    </a:ext>
                  </a:extLst>
                </a:gridCol>
                <a:gridCol w="153830">
                  <a:extLst>
                    <a:ext uri="{9D8B030D-6E8A-4147-A177-3AD203B41FA5}">
                      <a16:colId xmlns:a16="http://schemas.microsoft.com/office/drawing/2014/main" val="3709924449"/>
                    </a:ext>
                  </a:extLst>
                </a:gridCol>
                <a:gridCol w="283531">
                  <a:extLst>
                    <a:ext uri="{9D8B030D-6E8A-4147-A177-3AD203B41FA5}">
                      <a16:colId xmlns:a16="http://schemas.microsoft.com/office/drawing/2014/main" val="4148825910"/>
                    </a:ext>
                  </a:extLst>
                </a:gridCol>
                <a:gridCol w="235270">
                  <a:extLst>
                    <a:ext uri="{9D8B030D-6E8A-4147-A177-3AD203B41FA5}">
                      <a16:colId xmlns:a16="http://schemas.microsoft.com/office/drawing/2014/main" val="1685863171"/>
                    </a:ext>
                  </a:extLst>
                </a:gridCol>
                <a:gridCol w="153830">
                  <a:extLst>
                    <a:ext uri="{9D8B030D-6E8A-4147-A177-3AD203B41FA5}">
                      <a16:colId xmlns:a16="http://schemas.microsoft.com/office/drawing/2014/main" val="1766030720"/>
                    </a:ext>
                  </a:extLst>
                </a:gridCol>
                <a:gridCol w="283531">
                  <a:extLst>
                    <a:ext uri="{9D8B030D-6E8A-4147-A177-3AD203B41FA5}">
                      <a16:colId xmlns:a16="http://schemas.microsoft.com/office/drawing/2014/main" val="34022184"/>
                    </a:ext>
                  </a:extLst>
                </a:gridCol>
                <a:gridCol w="235270">
                  <a:extLst>
                    <a:ext uri="{9D8B030D-6E8A-4147-A177-3AD203B41FA5}">
                      <a16:colId xmlns:a16="http://schemas.microsoft.com/office/drawing/2014/main" val="443202802"/>
                    </a:ext>
                  </a:extLst>
                </a:gridCol>
                <a:gridCol w="153830">
                  <a:extLst>
                    <a:ext uri="{9D8B030D-6E8A-4147-A177-3AD203B41FA5}">
                      <a16:colId xmlns:a16="http://schemas.microsoft.com/office/drawing/2014/main" val="4067428287"/>
                    </a:ext>
                  </a:extLst>
                </a:gridCol>
                <a:gridCol w="283531">
                  <a:extLst>
                    <a:ext uri="{9D8B030D-6E8A-4147-A177-3AD203B41FA5}">
                      <a16:colId xmlns:a16="http://schemas.microsoft.com/office/drawing/2014/main" val="3511040330"/>
                    </a:ext>
                  </a:extLst>
                </a:gridCol>
                <a:gridCol w="235270">
                  <a:extLst>
                    <a:ext uri="{9D8B030D-6E8A-4147-A177-3AD203B41FA5}">
                      <a16:colId xmlns:a16="http://schemas.microsoft.com/office/drawing/2014/main" val="2847185831"/>
                    </a:ext>
                  </a:extLst>
                </a:gridCol>
                <a:gridCol w="153830">
                  <a:extLst>
                    <a:ext uri="{9D8B030D-6E8A-4147-A177-3AD203B41FA5}">
                      <a16:colId xmlns:a16="http://schemas.microsoft.com/office/drawing/2014/main" val="2749911183"/>
                    </a:ext>
                  </a:extLst>
                </a:gridCol>
                <a:gridCol w="271466">
                  <a:extLst>
                    <a:ext uri="{9D8B030D-6E8A-4147-A177-3AD203B41FA5}">
                      <a16:colId xmlns:a16="http://schemas.microsoft.com/office/drawing/2014/main" val="1886947800"/>
                    </a:ext>
                  </a:extLst>
                </a:gridCol>
                <a:gridCol w="271466">
                  <a:extLst>
                    <a:ext uri="{9D8B030D-6E8A-4147-A177-3AD203B41FA5}">
                      <a16:colId xmlns:a16="http://schemas.microsoft.com/office/drawing/2014/main" val="527743852"/>
                    </a:ext>
                  </a:extLst>
                </a:gridCol>
                <a:gridCol w="254028">
                  <a:extLst>
                    <a:ext uri="{9D8B030D-6E8A-4147-A177-3AD203B41FA5}">
                      <a16:colId xmlns:a16="http://schemas.microsoft.com/office/drawing/2014/main" val="764654893"/>
                    </a:ext>
                  </a:extLst>
                </a:gridCol>
              </a:tblGrid>
              <a:tr h="190500">
                <a:tc gridSpan="16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pplemental Table 1. Characteristics of participants by olfaction tertile groups (cross-sectional analysis)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03923488"/>
                  </a:ext>
                </a:extLst>
              </a:tr>
              <a:tr h="190500">
                <a:tc rowSpan="2" gridSpan="2"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riables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 gridSpan="3"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l, n = 162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9"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lfaction tertile groups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9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9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523023417"/>
                  </a:ext>
                </a:extLst>
              </a:tr>
              <a:tr h="238125">
                <a:tc gridSpan="2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1, n = 49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2, n = 44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3, n = 69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3847877"/>
                  </a:ext>
                </a:extLst>
              </a:tr>
              <a:tr h="144000">
                <a:tc gridSpan="14">
                  <a:txBody>
                    <a:bodyPr/>
                    <a:lstStyle/>
                    <a:p>
                      <a:pPr algn="l" fontAlgn="ctr"/>
                      <a:r>
                        <a:rPr lang="en-US" sz="900" u="sng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gnitive functions, mean±SD</a:t>
                      </a:r>
                      <a:endParaRPr lang="en-US" sz="900" b="0" i="1" u="sng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1" u="sng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956728526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9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obal cognitive, scor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6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5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5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6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957606598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9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ail Making Test part A, sec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5.9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9</a:t>
                      </a:r>
                      <a:r>
                        <a:rPr lang="en-US" sz="900" u="none" strike="noStrike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en-US" sz="9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.5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.1</a:t>
                      </a:r>
                      <a:r>
                        <a:rPr lang="en-US" sz="900" u="none" strike="noStrike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en-US" sz="9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3.1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7</a:t>
                      </a:r>
                      <a:r>
                        <a:rPr lang="en-US" sz="900" u="none" strike="noStrike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</a:t>
                      </a:r>
                      <a:endParaRPr lang="en-US" sz="9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.7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0</a:t>
                      </a:r>
                      <a:r>
                        <a:rPr lang="en-US" sz="900" u="none" strike="noStrike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US" sz="9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†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701176805"/>
                  </a:ext>
                </a:extLst>
              </a:tr>
              <a:tr h="144000">
                <a:tc gridSpan="14">
                  <a:txBody>
                    <a:bodyPr/>
                    <a:lstStyle/>
                    <a:p>
                      <a:pPr algn="l" fontAlgn="ctr"/>
                      <a:r>
                        <a:rPr lang="en-US" sz="900" u="sng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ysical performance, mean±SD</a:t>
                      </a:r>
                      <a:endParaRPr lang="en-US" sz="900" b="0" i="1" u="sng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1" u="sng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193061382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9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med up and go, sec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6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1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6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3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†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26370516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9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ve times chair stand, sec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1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7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9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8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†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906073003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9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and grip strength, kg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.4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2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.7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3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.1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9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.3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7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108968515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9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e leg standing with open eyes, sec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1.1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.0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.1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.0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.9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5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4.7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.8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†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715324569"/>
                  </a:ext>
                </a:extLst>
              </a:tr>
              <a:tr h="144000">
                <a:tc gridSpan="15">
                  <a:txBody>
                    <a:bodyPr/>
                    <a:lstStyle/>
                    <a:p>
                      <a:pPr algn="l" fontAlgn="ctr"/>
                      <a:r>
                        <a:rPr lang="en-US" sz="900" u="sng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orbidities, n (%)</a:t>
                      </a:r>
                      <a:endParaRPr lang="en-US" sz="900" b="0" i="1" u="sng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extLst>
                  <a:ext uri="{0D108BD9-81ED-4DB2-BD59-A6C34878D82A}">
                    <a16:rowId xmlns:a16="http://schemas.microsoft.com/office/drawing/2014/main" val="245870208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1" u="sng" strike="noStrike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moking, n (%)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   </a:t>
                      </a:r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 (4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2 (4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2 (5)</a:t>
                      </a:r>
                      <a:r>
                        <a:rPr lang="en-US" sz="900" u="none" strike="noStrike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en-US" sz="9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2 (3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extLst>
                  <a:ext uri="{0D108BD9-81ED-4DB2-BD59-A6C34878D82A}">
                    <a16:rowId xmlns:a16="http://schemas.microsoft.com/office/drawing/2014/main" val="1246415549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sng" strike="noStrike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900" b="0" i="1" u="sng" strike="noStrike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ok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4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4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6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extLst>
                  <a:ext uri="{0D108BD9-81ED-4DB2-BD59-A6C34878D82A}">
                    <a16:rowId xmlns:a16="http://schemas.microsoft.com/office/drawing/2014/main" val="3229971948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sng" strike="noStrike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900" b="0" i="1" u="sng" strike="noStrike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rdiovascular 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3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6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9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extLst>
                  <a:ext uri="{0D108BD9-81ED-4DB2-BD59-A6C34878D82A}">
                    <a16:rowId xmlns:a16="http://schemas.microsoft.com/office/drawing/2014/main" val="3598515659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900" b="0" i="0" u="none" strike="noStrike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betes mellitus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5)</a:t>
                      </a:r>
                      <a:r>
                        <a:rPr lang="en-US" sz="900" u="none" strike="noStrike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en-US" sz="9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9)</a:t>
                      </a:r>
                      <a:r>
                        <a:rPr lang="en-US" sz="900" u="none" strike="noStrike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en-US" sz="9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6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9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extLst>
                  <a:ext uri="{0D108BD9-81ED-4DB2-BD59-A6C34878D82A}">
                    <a16:rowId xmlns:a16="http://schemas.microsoft.com/office/drawing/2014/main" val="1520088310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900" b="0" i="0" u="none" strike="noStrike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ypertension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9)</a:t>
                      </a:r>
                      <a:r>
                        <a:rPr lang="en-US" sz="900" u="none" strike="noStrike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en-US" sz="9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2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2)</a:t>
                      </a:r>
                      <a:r>
                        <a:rPr lang="en-US" altLang="ja-JP" sz="900" u="none" strike="noStrike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</a:t>
                      </a:r>
                      <a:endParaRPr lang="en-US" sz="9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9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extLst>
                  <a:ext uri="{0D108BD9-81ED-4DB2-BD59-A6C34878D82A}">
                    <a16:rowId xmlns:a16="http://schemas.microsoft.com/office/drawing/2014/main" val="3366734879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900" b="0" i="0" u="none" strike="noStrike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</a:t>
                      </a:r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perlipidemia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4)</a:t>
                      </a:r>
                      <a:r>
                        <a:rPr lang="en-US" sz="900" u="none" strike="noStrike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en-US" sz="9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4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6)</a:t>
                      </a:r>
                      <a:r>
                        <a:rPr lang="en-US" altLang="ja-JP" sz="900" u="none" strike="noStrike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</a:t>
                      </a:r>
                      <a:endParaRPr lang="en-US" sz="9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9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extLst>
                  <a:ext uri="{0D108BD9-81ED-4DB2-BD59-A6C34878D82A}">
                    <a16:rowId xmlns:a16="http://schemas.microsoft.com/office/drawing/2014/main" val="3406571834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900" b="0" i="0" u="none" strike="noStrike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thopedic diseas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5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4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8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4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extLst>
                  <a:ext uri="{0D108BD9-81ED-4DB2-BD59-A6C34878D82A}">
                    <a16:rowId xmlns:a16="http://schemas.microsoft.com/office/drawing/2014/main" val="2568716692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900" b="0" i="0" u="none" strike="noStrike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ncer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9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9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4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7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7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extLst>
                  <a:ext uri="{0D108BD9-81ED-4DB2-BD59-A6C34878D82A}">
                    <a16:rowId xmlns:a16="http://schemas.microsoft.com/office/drawing/2014/main" val="2229225668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ease of the thyroid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5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extLst>
                  <a:ext uri="{0D108BD9-81ED-4DB2-BD59-A6C34878D82A}">
                    <a16:rowId xmlns:a16="http://schemas.microsoft.com/office/drawing/2014/main" val="3563080917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ease of nervous system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3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extLst>
                  <a:ext uri="{0D108BD9-81ED-4DB2-BD59-A6C34878D82A}">
                    <a16:rowId xmlns:a16="http://schemas.microsoft.com/office/drawing/2014/main" val="1936291805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ease of lung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)</a:t>
                      </a:r>
                      <a:r>
                        <a:rPr lang="en-US" sz="900" u="none" strike="noStrike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en-US" sz="9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)</a:t>
                      </a:r>
                      <a:r>
                        <a:rPr lang="en-US" sz="900" u="none" strike="noStrike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</a:t>
                      </a:r>
                      <a:endParaRPr lang="en-US" sz="90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/>
                </a:tc>
                <a:extLst>
                  <a:ext uri="{0D108BD9-81ED-4DB2-BD59-A6C34878D82A}">
                    <a16:rowId xmlns:a16="http://schemas.microsoft.com/office/drawing/2014/main" val="3977980495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ease of immunity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3)</a:t>
                      </a:r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701" marR="7701" marT="770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6787026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D6761B14-E6B5-0BA6-19D1-19097C6C791D}"/>
              </a:ext>
            </a:extLst>
          </p:cNvPr>
          <p:cNvSpPr txBox="1"/>
          <p:nvPr/>
        </p:nvSpPr>
        <p:spPr>
          <a:xfrm>
            <a:off x="2837751" y="5053139"/>
            <a:ext cx="6101970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E: </a:t>
            </a:r>
          </a:p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D: standard deviation. </a:t>
            </a:r>
          </a:p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cognitive function and physical performance, p-values for olfaction tertile groups were calculated using analysis of variance. </a:t>
            </a:r>
          </a:p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comorbidities, p-values for olfaction tertile groups were calculated using chi-square tests. </a:t>
            </a:r>
          </a:p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p &lt; 0.05 in one-way analysis of variance, † p &lt; 0.05 are linear trend (cognitive function and physical performance).</a:t>
            </a:r>
          </a:p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: n = 161; b = 42; c: n = 38; d: n = 64; e: n = 43; f: n = 68. </a:t>
            </a:r>
          </a:p>
        </p:txBody>
      </p:sp>
    </p:spTree>
    <p:extLst>
      <p:ext uri="{BB962C8B-B14F-4D97-AF65-F5344CB8AC3E}">
        <p14:creationId xmlns:p14="http://schemas.microsoft.com/office/powerpoint/2010/main" val="34681943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22d571ce-5d5e-4577-851b-36fe2b87e29c" xsi:nil="true"/>
    <lcf76f155ced4ddcb4097134ff3c332f xmlns="7805362c-7fb7-47ff-9049-83b2c46e6485">
      <Terms xmlns="http://schemas.microsoft.com/office/infopath/2007/PartnerControls"/>
    </lcf76f155ced4ddcb4097134ff3c332f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2D935350FB4524AA9B0551AC744F54C" ma:contentTypeVersion="18" ma:contentTypeDescription="Create a new document." ma:contentTypeScope="" ma:versionID="5d2d8db6fea1d1812808fd55738c9f69">
  <xsd:schema xmlns:xsd="http://www.w3.org/2001/XMLSchema" xmlns:xs="http://www.w3.org/2001/XMLSchema" xmlns:p="http://schemas.microsoft.com/office/2006/metadata/properties" xmlns:ns2="7805362c-7fb7-47ff-9049-83b2c46e6485" xmlns:ns3="22d571ce-5d5e-4577-851b-36fe2b87e29c" targetNamespace="http://schemas.microsoft.com/office/2006/metadata/properties" ma:root="true" ma:fieldsID="1fde52f5973b0c0dfb47cad0919e8cf1" ns2:_="" ns3:_="">
    <xsd:import namespace="7805362c-7fb7-47ff-9049-83b2c46e6485"/>
    <xsd:import namespace="22d571ce-5d5e-4577-851b-36fe2b87e29c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Location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805362c-7fb7-47ff-9049-83b2c46e648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d6f95cfc-685b-4d9e-acc9-81b202a9d85d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Location" ma:index="23" nillable="true" ma:displayName="Location" ma:description="" ma:indexed="true" ma:internalName="MediaServiceLocation" ma:readOnly="true">
      <xsd:simpleType>
        <xsd:restriction base="dms:Text"/>
      </xsd:simpleType>
    </xsd:element>
    <xsd:element name="MediaServiceObjectDetectorVersions" ma:index="24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2d571ce-5d5e-4577-851b-36fe2b87e29c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ad7e4307-db98-45a2-a7ea-4b20717fe51c}" ma:internalName="TaxCatchAll" ma:showField="CatchAllData" ma:web="22d571ce-5d5e-4577-851b-36fe2b87e29c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2E031986-14B0-431B-A586-684DD4E2E086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EB3F242C-91E5-4E92-97FA-D04C0779A03D}">
  <ds:schemaRefs>
    <ds:schemaRef ds:uri="http://schemas.microsoft.com/office/2006/metadata/properties"/>
    <ds:schemaRef ds:uri="http://schemas.microsoft.com/office/infopath/2007/PartnerControls"/>
    <ds:schemaRef ds:uri="22d571ce-5d5e-4577-851b-36fe2b87e29c"/>
    <ds:schemaRef ds:uri="7805362c-7fb7-47ff-9049-83b2c46e6485"/>
  </ds:schemaRefs>
</ds:datastoreItem>
</file>

<file path=customXml/itemProps3.xml><?xml version="1.0" encoding="utf-8"?>
<ds:datastoreItem xmlns:ds="http://schemas.openxmlformats.org/officeDocument/2006/customXml" ds:itemID="{4F817615-3914-4657-93D1-BB78095578E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805362c-7fb7-47ff-9049-83b2c46e6485"/>
    <ds:schemaRef ds:uri="22d571ce-5d5e-4577-851b-36fe2b87e29c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2256</TotalTime>
  <Words>528</Words>
  <Application>Microsoft Office PowerPoint</Application>
  <PresentationFormat>ワイド画面</PresentationFormat>
  <Paragraphs>22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ose yujiro</dc:creator>
  <cp:lastModifiedBy>古瀬 裕次郎</cp:lastModifiedBy>
  <cp:revision>198</cp:revision>
  <dcterms:created xsi:type="dcterms:W3CDTF">2021-09-29T01:11:49Z</dcterms:created>
  <dcterms:modified xsi:type="dcterms:W3CDTF">2025-07-30T07:22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2D935350FB4524AA9B0551AC744F54C</vt:lpwstr>
  </property>
</Properties>
</file>